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9" d="100"/>
          <a:sy n="79" d="100"/>
        </p:scale>
        <p:origin x="85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AB687A-AA52-5674-FF66-CBD9AE19A9D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4079847-88FA-72B8-7D5F-D884F2317B0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18D5EA-F444-51B4-C6F0-DF360C0029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663B-D3F3-4A2C-8B48-FE1A79A1CDE6}" type="datetimeFigureOut">
              <a:rPr lang="en-ZA" smtClean="0"/>
              <a:t>2024/05/03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DE34B8-3044-4BF4-E223-AA58DA9041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8BDC0E-DD49-1018-9DF2-FDD4F55685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CE407-0F66-4A84-A620-11CCE2D8E32A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9771074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3A7E02-FE38-EF9A-B49C-C2CBEC29F4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76F7238-A8DE-1DA8-9291-4B4B0680295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A9B8EB-71F3-7250-5BFD-214303DE7B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663B-D3F3-4A2C-8B48-FE1A79A1CDE6}" type="datetimeFigureOut">
              <a:rPr lang="en-ZA" smtClean="0"/>
              <a:t>2024/05/03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592AF9-7390-C285-3EB0-286DE45E63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DDCE2D-7B92-BD84-7045-FEAEAF4292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CE407-0F66-4A84-A620-11CCE2D8E32A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9231606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00E9788-6F41-E747-0A5C-5F42DB6C2AA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CE4DA47-5177-0F75-2F90-B3827A92A9F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335954-7E78-F481-8B3C-91A0399532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663B-D3F3-4A2C-8B48-FE1A79A1CDE6}" type="datetimeFigureOut">
              <a:rPr lang="en-ZA" smtClean="0"/>
              <a:t>2024/05/03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CDD1AB-F6B6-3B41-1380-7F079B596F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9165CA-E9EC-5BC9-9699-56F625FF4C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CE407-0F66-4A84-A620-11CCE2D8E32A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3036492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00DB34-ACEC-3644-ECE9-34914E14BB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FFF1B76-418F-39FF-E97B-9581EBECC58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040546-E7D2-8D65-F918-7B31AB63E0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663B-D3F3-4A2C-8B48-FE1A79A1CDE6}" type="datetimeFigureOut">
              <a:rPr lang="en-ZA" smtClean="0"/>
              <a:t>2024/05/03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1491B3A-1D20-1414-884D-F6B5AFD8C9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9D27D4-6E03-6D55-7343-8827D9BD33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CE407-0F66-4A84-A620-11CCE2D8E32A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8382856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D1FD80-8743-3D60-2A0D-3352CACD44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83864B8-7E9D-65A8-A58D-133FE08ED6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5B61C25-7D8D-B2AC-9515-2D91C89BEB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663B-D3F3-4A2C-8B48-FE1A79A1CDE6}" type="datetimeFigureOut">
              <a:rPr lang="en-ZA" smtClean="0"/>
              <a:t>2024/05/03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A35A0D-BA71-BC36-0271-C7AFF37DD1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CD80DB5-7450-EE3F-FA49-2DCDC5AD57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CE407-0F66-4A84-A620-11CCE2D8E32A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248779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61DCF6-ECB2-8871-7124-953AD31E5A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FC4DF66-A8A9-92C9-D6BC-D8DF2AA48C2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318484A-304B-0EBD-57C5-07869A1EE5A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EA07C47-A4AA-C3FF-FB7B-371BA9515D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663B-D3F3-4A2C-8B48-FE1A79A1CDE6}" type="datetimeFigureOut">
              <a:rPr lang="en-ZA" smtClean="0"/>
              <a:t>2024/05/03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A83DF2C-C0AC-0ED1-45D1-F70CE5ABDA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3429CAC-63BD-6403-C7E5-5EAD6C6946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CE407-0F66-4A84-A620-11CCE2D8E32A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2113326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80F3B5-6451-DDCD-2823-401FDCB23F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7398B42-4C57-852A-6B9E-3E7BC71A460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CBA2F34-0565-680C-6A61-0F17A728AD0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7E3092E-08DB-0459-6DC3-272AFD96135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29A01A0-F52E-CDF1-C012-42FEE6594C7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D6AB04B-0AAF-EAA0-88D9-C1B9C31313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663B-D3F3-4A2C-8B48-FE1A79A1CDE6}" type="datetimeFigureOut">
              <a:rPr lang="en-ZA" smtClean="0"/>
              <a:t>2024/05/03</a:t>
            </a:fld>
            <a:endParaRPr lang="en-Z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69D6ECE-0900-4679-1FED-5319ED68C5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2B03FF6-D33F-7663-E7EE-260A12AF7C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CE407-0F66-4A84-A620-11CCE2D8E32A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0003591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CEB43D-69FC-41AA-9761-0F593BEAB5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751F8EE-0855-1D08-3956-E27DCE05BB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663B-D3F3-4A2C-8B48-FE1A79A1CDE6}" type="datetimeFigureOut">
              <a:rPr lang="en-ZA" smtClean="0"/>
              <a:t>2024/05/03</a:t>
            </a:fld>
            <a:endParaRPr lang="en-Z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881F601-6302-7C11-BBD9-1B47A40880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356D491-7D4F-9CB3-04A1-D37A0A4D94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CE407-0F66-4A84-A620-11CCE2D8E32A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0911570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D82F517-C36B-8E1B-CF55-CA2032E778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663B-D3F3-4A2C-8B48-FE1A79A1CDE6}" type="datetimeFigureOut">
              <a:rPr lang="en-ZA" smtClean="0"/>
              <a:t>2024/05/03</a:t>
            </a:fld>
            <a:endParaRPr lang="en-Z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F24A385-F726-DBC0-181F-4D5E8C6CD3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213FECC-88C0-5C39-9573-EBC24F5901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CE407-0F66-4A84-A620-11CCE2D8E32A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7384770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34830B-F0D3-D389-AB36-CE9538609B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5742987-7380-7DC0-0959-0181D0DB3B6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9ACEE8E-6C4C-4B3A-A6EC-34B571159AE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B3C3A2D-9AC0-2F8D-6068-57F3F0B81B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663B-D3F3-4A2C-8B48-FE1A79A1CDE6}" type="datetimeFigureOut">
              <a:rPr lang="en-ZA" smtClean="0"/>
              <a:t>2024/05/03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373228D-4B0B-8756-B4B9-5B52938577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D5A08DE-B647-7FDA-A7BB-0CB6329456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CE407-0F66-4A84-A620-11CCE2D8E32A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4789200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225597-9A5B-C796-1ACB-9596E73231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476450F-5606-D95E-270F-E0560D766B9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95C7428-AC5F-879A-AFC9-D34A08B6D6B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584F3FD-5F91-556F-C75B-C8FF00A868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663B-D3F3-4A2C-8B48-FE1A79A1CDE6}" type="datetimeFigureOut">
              <a:rPr lang="en-ZA" smtClean="0"/>
              <a:t>2024/05/03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4EC2552-6876-0E77-0961-1CE87DB41B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84006B6-E896-0068-32F4-03DB120B7C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CE407-0F66-4A84-A620-11CCE2D8E32A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4089443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174A2B7-5399-F066-D621-FC91EF76B3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A87B9A3-A3C9-7767-6869-11076828D4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D3641F-2998-DF2D-4B01-F7640E32052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332663B-D3F3-4A2C-8B48-FE1A79A1CDE6}" type="datetimeFigureOut">
              <a:rPr lang="en-ZA" smtClean="0"/>
              <a:t>2024/05/03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62CFFC-1F53-818E-0021-D6384166EBB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CE4D3C-78F2-0951-0379-0A0D02D6597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B4CE407-0F66-4A84-A620-11CCE2D8E32A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9756694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black and white photo of a dna strand&#10;&#10;Description automatically generated">
            <a:extLst>
              <a:ext uri="{FF2B5EF4-FFF2-40B4-BE49-F238E27FC236}">
                <a16:creationId xmlns:a16="http://schemas.microsoft.com/office/drawing/2014/main" id="{402DC116-75DC-BC1D-A882-F5B287F3DDB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619184"/>
            <a:ext cx="12192000" cy="3619632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B5923E21-9E8C-4F4F-5263-53E2F3DCC584}"/>
              </a:ext>
            </a:extLst>
          </p:cNvPr>
          <p:cNvSpPr txBox="1"/>
          <p:nvPr/>
        </p:nvSpPr>
        <p:spPr>
          <a:xfrm flipH="1">
            <a:off x="787939" y="1297020"/>
            <a:ext cx="836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NC1</a:t>
            </a:r>
            <a:endParaRPr lang="en-ZA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38DB8DF-5C8F-A2FE-B7DF-703978086AF6}"/>
              </a:ext>
            </a:extLst>
          </p:cNvPr>
          <p:cNvSpPr txBox="1"/>
          <p:nvPr/>
        </p:nvSpPr>
        <p:spPr>
          <a:xfrm>
            <a:off x="223736" y="1297020"/>
            <a:ext cx="4819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M</a:t>
            </a:r>
            <a:endParaRPr lang="en-ZA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0599EC0-0FC6-374D-81C3-E2F916D1782F}"/>
              </a:ext>
            </a:extLst>
          </p:cNvPr>
          <p:cNvSpPr txBox="1"/>
          <p:nvPr/>
        </p:nvSpPr>
        <p:spPr>
          <a:xfrm flipH="1">
            <a:off x="1459148" y="1297020"/>
            <a:ext cx="6609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C</a:t>
            </a:r>
            <a:endParaRPr lang="en-ZA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EA457F9-D29F-A4F6-1A97-FDF92C261C58}"/>
              </a:ext>
            </a:extLst>
          </p:cNvPr>
          <p:cNvSpPr txBox="1"/>
          <p:nvPr/>
        </p:nvSpPr>
        <p:spPr>
          <a:xfrm flipH="1">
            <a:off x="2103642" y="1297019"/>
            <a:ext cx="3996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2</a:t>
            </a:r>
            <a:endParaRPr lang="en-ZA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1F3484A-C142-DE21-9D90-F5F83BA327C6}"/>
              </a:ext>
            </a:extLst>
          </p:cNvPr>
          <p:cNvSpPr txBox="1"/>
          <p:nvPr/>
        </p:nvSpPr>
        <p:spPr>
          <a:xfrm flipH="1">
            <a:off x="2636196" y="1297019"/>
            <a:ext cx="593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3</a:t>
            </a:r>
            <a:endParaRPr lang="en-ZA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E1B9071-B764-D534-3D6D-E4B190C86565}"/>
              </a:ext>
            </a:extLst>
          </p:cNvPr>
          <p:cNvSpPr txBox="1"/>
          <p:nvPr/>
        </p:nvSpPr>
        <p:spPr>
          <a:xfrm flipH="1">
            <a:off x="3161489" y="1297019"/>
            <a:ext cx="7397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4</a:t>
            </a:r>
            <a:endParaRPr lang="en-ZA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1425A7C-19DF-C9AA-653A-B57CFD0A6DBB}"/>
              </a:ext>
            </a:extLst>
          </p:cNvPr>
          <p:cNvSpPr txBox="1"/>
          <p:nvPr/>
        </p:nvSpPr>
        <p:spPr>
          <a:xfrm flipH="1">
            <a:off x="3755368" y="1297019"/>
            <a:ext cx="6712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5</a:t>
            </a:r>
            <a:endParaRPr lang="en-ZA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42A631C-7A9E-048D-45BF-8987AAB6059C}"/>
              </a:ext>
            </a:extLst>
          </p:cNvPr>
          <p:cNvSpPr txBox="1"/>
          <p:nvPr/>
        </p:nvSpPr>
        <p:spPr>
          <a:xfrm flipH="1">
            <a:off x="4426578" y="1297019"/>
            <a:ext cx="7450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6</a:t>
            </a:r>
            <a:endParaRPr lang="en-ZA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01B57D5-0057-BADD-1F87-F488F981A933}"/>
              </a:ext>
            </a:extLst>
          </p:cNvPr>
          <p:cNvSpPr txBox="1"/>
          <p:nvPr/>
        </p:nvSpPr>
        <p:spPr>
          <a:xfrm flipH="1">
            <a:off x="4951868" y="1297019"/>
            <a:ext cx="6609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  7</a:t>
            </a:r>
            <a:endParaRPr lang="en-ZA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AFCF7DD-A6B4-3258-983F-2E1F6E7145CA}"/>
              </a:ext>
            </a:extLst>
          </p:cNvPr>
          <p:cNvSpPr txBox="1"/>
          <p:nvPr/>
        </p:nvSpPr>
        <p:spPr>
          <a:xfrm>
            <a:off x="5591853" y="1297019"/>
            <a:ext cx="593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</a:t>
            </a:r>
            <a:endParaRPr lang="en-ZA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415A6B4-089C-EAE2-2125-AB91811A7EB8}"/>
              </a:ext>
            </a:extLst>
          </p:cNvPr>
          <p:cNvSpPr txBox="1"/>
          <p:nvPr/>
        </p:nvSpPr>
        <p:spPr>
          <a:xfrm>
            <a:off x="6185732" y="1297019"/>
            <a:ext cx="5041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9</a:t>
            </a:r>
            <a:endParaRPr lang="en-ZA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9D35D18-99DC-0121-5B09-006F11E50BBE}"/>
              </a:ext>
            </a:extLst>
          </p:cNvPr>
          <p:cNvSpPr txBox="1"/>
          <p:nvPr/>
        </p:nvSpPr>
        <p:spPr>
          <a:xfrm flipH="1">
            <a:off x="6752687" y="1297019"/>
            <a:ext cx="5041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0</a:t>
            </a:r>
            <a:endParaRPr lang="en-ZA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AB0AA25-F312-78E5-303C-9BCBFC8F83DC}"/>
              </a:ext>
            </a:extLst>
          </p:cNvPr>
          <p:cNvSpPr txBox="1"/>
          <p:nvPr/>
        </p:nvSpPr>
        <p:spPr>
          <a:xfrm>
            <a:off x="7468484" y="1273700"/>
            <a:ext cx="593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1</a:t>
            </a:r>
            <a:endParaRPr lang="en-ZA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C76AA01-1208-9F65-C3FC-541B5612AF71}"/>
              </a:ext>
            </a:extLst>
          </p:cNvPr>
          <p:cNvSpPr txBox="1"/>
          <p:nvPr/>
        </p:nvSpPr>
        <p:spPr>
          <a:xfrm>
            <a:off x="8035439" y="1261776"/>
            <a:ext cx="593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2</a:t>
            </a:r>
            <a:endParaRPr lang="en-ZA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BD41223F-47FF-C82B-6420-3F2F690548F6}"/>
              </a:ext>
            </a:extLst>
          </p:cNvPr>
          <p:cNvSpPr txBox="1"/>
          <p:nvPr/>
        </p:nvSpPr>
        <p:spPr>
          <a:xfrm>
            <a:off x="8544133" y="1273700"/>
            <a:ext cx="593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3</a:t>
            </a:r>
            <a:endParaRPr lang="en-ZA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BAF4EFCD-5DAA-D00C-CAD7-E5F6CC0F634E}"/>
              </a:ext>
            </a:extLst>
          </p:cNvPr>
          <p:cNvSpPr txBox="1"/>
          <p:nvPr/>
        </p:nvSpPr>
        <p:spPr>
          <a:xfrm flipH="1">
            <a:off x="9172663" y="1297020"/>
            <a:ext cx="5591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4</a:t>
            </a:r>
            <a:endParaRPr lang="en-ZA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D1AC4B5-62CD-B606-A7A2-F54F8B6AF193}"/>
              </a:ext>
            </a:extLst>
          </p:cNvPr>
          <p:cNvSpPr txBox="1"/>
          <p:nvPr/>
        </p:nvSpPr>
        <p:spPr>
          <a:xfrm>
            <a:off x="9697954" y="1315005"/>
            <a:ext cx="5415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5</a:t>
            </a:r>
            <a:endParaRPr lang="en-ZA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8D0D6987-A64C-F602-2D76-BE3F38BCF3AA}"/>
              </a:ext>
            </a:extLst>
          </p:cNvPr>
          <p:cNvSpPr txBox="1"/>
          <p:nvPr/>
        </p:nvSpPr>
        <p:spPr>
          <a:xfrm>
            <a:off x="10291835" y="1316259"/>
            <a:ext cx="7004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NC2</a:t>
            </a:r>
            <a:endParaRPr lang="en-ZA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D6FCFA2-D5AC-EF05-0A68-7E1A43C63C20}"/>
              </a:ext>
            </a:extLst>
          </p:cNvPr>
          <p:cNvSpPr txBox="1"/>
          <p:nvPr/>
        </p:nvSpPr>
        <p:spPr>
          <a:xfrm>
            <a:off x="11044577" y="1297019"/>
            <a:ext cx="5689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C</a:t>
            </a:r>
            <a:endParaRPr lang="en-ZA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92C05020-2044-B73C-7A39-F92C6E5C3DDD}"/>
              </a:ext>
            </a:extLst>
          </p:cNvPr>
          <p:cNvSpPr txBox="1"/>
          <p:nvPr/>
        </p:nvSpPr>
        <p:spPr>
          <a:xfrm>
            <a:off x="11586147" y="1261776"/>
            <a:ext cx="628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M</a:t>
            </a:r>
            <a:endParaRPr lang="en-ZA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6BD22EF-A0F1-91CF-5689-72F2652D747D}"/>
              </a:ext>
            </a:extLst>
          </p:cNvPr>
          <p:cNvSpPr txBox="1"/>
          <p:nvPr/>
        </p:nvSpPr>
        <p:spPr>
          <a:xfrm>
            <a:off x="0" y="5593404"/>
            <a:ext cx="12091481" cy="6771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/>
              <a:t>Fig S1: Gel electrophoresis image illustrating amplification of </a:t>
            </a:r>
            <a:r>
              <a:rPr lang="en-US" sz="1000" i="1" dirty="0" err="1"/>
              <a:t>esxA</a:t>
            </a:r>
            <a:r>
              <a:rPr lang="en-US" sz="1000" i="1" dirty="0"/>
              <a:t> gene fragment  using M. smegmatis derived primers. Lanes M are 100bp Molecular weight markers (O’ gene ruler from </a:t>
            </a:r>
            <a:r>
              <a:rPr lang="en-US" sz="1000" i="1" dirty="0" err="1"/>
              <a:t>Thermofisher</a:t>
            </a:r>
            <a:r>
              <a:rPr lang="en-US" sz="1000" i="1" dirty="0"/>
              <a:t> Scientific), Lane 6, 7 and  </a:t>
            </a:r>
            <a:r>
              <a:rPr lang="en-US" sz="1000" i="1" dirty="0" err="1"/>
              <a:t>and</a:t>
            </a:r>
            <a:r>
              <a:rPr lang="en-US" sz="1000" i="1" dirty="0"/>
              <a:t> 8 are positive samples, Lane 2, 3, 4, 9, 10,11,12,13,14,and 15 are negative samples while lanes PC are M. smegmatis positive controls and lanes NC are negative controls</a:t>
            </a:r>
            <a:endParaRPr lang="en-ZA" sz="1000" i="1" dirty="0"/>
          </a:p>
          <a:p>
            <a:endParaRPr lang="en-ZA" dirty="0"/>
          </a:p>
        </p:txBody>
      </p:sp>
    </p:spTree>
    <p:extLst>
      <p:ext uri="{BB962C8B-B14F-4D97-AF65-F5344CB8AC3E}">
        <p14:creationId xmlns:p14="http://schemas.microsoft.com/office/powerpoint/2010/main" val="14674359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98</Words>
  <Application>Microsoft Office PowerPoint</Application>
  <PresentationFormat>Widescreen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>Agricultural Research Counci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omakorinte Gcebe</dc:creator>
  <cp:lastModifiedBy>Nomakorinte Gcebe</cp:lastModifiedBy>
  <cp:revision>4</cp:revision>
  <dcterms:created xsi:type="dcterms:W3CDTF">2024-04-30T09:21:29Z</dcterms:created>
  <dcterms:modified xsi:type="dcterms:W3CDTF">2024-05-03T06:11:24Z</dcterms:modified>
</cp:coreProperties>
</file>